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1" r:id="rId2"/>
    <p:sldId id="306" r:id="rId3"/>
    <p:sldId id="305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피하지방" id="{F716DF51-6F90-4B4F-BE5A-8674815CB062}">
          <p14:sldIdLst>
            <p14:sldId id="301"/>
            <p14:sldId id="306"/>
            <p14:sldId id="305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63" autoAdjust="0"/>
    <p:restoredTop sz="94660"/>
  </p:normalViewPr>
  <p:slideViewPr>
    <p:cSldViewPr snapToGrid="0">
      <p:cViewPr varScale="1">
        <p:scale>
          <a:sx n="84" d="100"/>
          <a:sy n="84" d="100"/>
        </p:scale>
        <p:origin x="427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FF004F9-EE4F-CCCC-D503-EC787D02F7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013E566-F0CA-2818-CA06-4D3174BCE5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5AFBDBF-EC6B-A215-8E34-1AE76F5FD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24E4FE6-C0EC-06CA-0A32-F0E7A0C32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5EC5863-B16B-84FB-1766-2E9811672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3519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8CDE93C-0109-4A4E-43B9-0213AAB99B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AAFB057-5F40-C5A2-22BB-83082ECF26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A0C880F-E7B2-B45F-F9E6-5528EEAC8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007A7B8-EE52-CE16-3974-123658791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60CAC97-288C-D931-0E74-B1D3B39AF2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439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CA04DD6C-9CE0-6944-D220-85FD0B84CD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01985CD-7FDF-DFC9-F521-5F5093D9E3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DE8D41D-5280-A3D2-35FE-6DE492A37E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E2CD35F-96AF-B553-1190-6459645E2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470B3A7-2C66-ABD0-397F-1514780C21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9320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8A05D22-0906-24B0-A505-042093BA54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6B14401-B820-EC84-72ED-CFEA254031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BD1C3AB-52E5-864F-5F62-555A5DA3E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9FDBB4-973B-7CE3-5C7A-B9A605E18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ED574F1-4230-8825-34FE-C0C752C2E1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3618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B44BB08-891A-F8A6-399A-F6BFE6A2EE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C673FAB-2826-A844-78E9-325AF3BC47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D564EAA-0533-1A03-A510-472A2580B9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0A3C6E6-8228-86F2-EB3B-618BBBC34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215B8C8-4B88-7140-0651-52CB422E6F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0871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8311744-2CD0-1421-838F-AF96034D33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8FC3610-6349-D665-74B8-F6FDCFFD30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BDDA4ED-4A71-A7F1-3CB6-E4BB0FB409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F140104-1B9B-9A48-09F8-3658E387E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12879F8-1173-DA5A-BA26-C74E3D163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6143ED8-B794-3F75-FA3A-980C879FB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0331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C5B8C77-2ED9-3A02-6279-A5201BBA64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96AFA86-1627-0BC3-7A51-F036FB815F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BB7686C-9CEC-9940-5F09-4219A79228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6D6D07CA-FA70-7D48-6BBC-CA38B63C54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9346B40-B84B-2EC6-A36F-E5775BC43D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703B204-6146-2C3F-CE3D-7B71F47BB0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DEB459B-0C5C-6EA7-1E33-28A76AFAC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267179A-D674-0D5D-626D-7637DF68D6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6461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9F502F-D271-44E4-E513-399113A6B6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56376AD6-C767-9E38-4662-82B7C44D9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96F8667F-B7BF-AC41-AD81-B8E1FE5CE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A171E6E9-4202-793A-7FB7-191775912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2183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FB4DCFA4-2BAA-03CB-3CC8-2ADBB49ED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E8DF7362-C7CD-DF5A-A6AE-417FCF39CF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488B1C90-5D5A-F19A-3DEC-779E3B88E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1090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207330C-265D-B470-C1AD-E34671A34A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3072780-21CF-19DE-FE8F-2CC2CF51A8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78DD13C-D4FF-2165-D403-B28FA03CDF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52B7F5D-AB50-9F7A-17C2-2A720D51A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474E21C-EA9C-E838-8445-82B659B11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7B7B1BD-0634-C2CD-7053-A69B64ACB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916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D2A994D-2B37-3F13-37F1-7782FDE11F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BFB29955-698B-9925-1F40-935DD0FE4D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51C5572-9E3A-3B90-EAF0-21CF4FA66E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DD70FA7-CDE7-559C-C2BA-3419335F6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14C6416-1D16-4D38-FF3D-9A59B963E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F275C77-391B-84E4-58E3-2A43FA6EC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8760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D9284F5F-5D84-9F9E-CCAD-29F5BF51BD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FB63952-785C-1245-F508-4A1B267223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4E34AD0-AD4D-E262-02B1-8D0E62A6C6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75A6CF-ED62-4384-AD2A-4C3FE448AC71}" type="datetimeFigureOut">
              <a:rPr lang="ko-KR" altLang="en-US" smtClean="0"/>
              <a:t>2024-05-0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4A698A3-763E-CD70-7B0B-B4B444A7AC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95B05E5-A1F3-2636-1A37-E8FD0EF3E3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1100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9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12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openxmlformats.org/officeDocument/2006/relationships/image" Target="../media/image8.png"/><Relationship Id="rId5" Type="http://schemas.openxmlformats.org/officeDocument/2006/relationships/image" Target="../media/image4.png"/><Relationship Id="rId10" Type="http://schemas.openxmlformats.org/officeDocument/2006/relationships/image" Target="../media/image7.png"/><Relationship Id="rId4" Type="http://schemas.openxmlformats.org/officeDocument/2006/relationships/image" Target="../media/image3.png"/><Relationship Id="rId9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png"/><Relationship Id="rId11" Type="http://schemas.openxmlformats.org/officeDocument/2006/relationships/image" Target="../media/image29.png"/><Relationship Id="rId5" Type="http://schemas.openxmlformats.org/officeDocument/2006/relationships/image" Target="../media/image23.png"/><Relationship Id="rId10" Type="http://schemas.openxmlformats.org/officeDocument/2006/relationships/image" Target="../media/image28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817740" y="5912385"/>
            <a:ext cx="3321710" cy="83099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 H = High Fat Diet</a:t>
            </a:r>
          </a:p>
          <a:p>
            <a:r>
              <a:rPr lang="en-US" altLang="ko-KR" sz="1200" dirty="0"/>
              <a:t>- HG =High Fat Diet + </a:t>
            </a:r>
            <a:r>
              <a:rPr lang="en-US" altLang="ko-KR" sz="1200" dirty="0" err="1"/>
              <a:t>Genistein</a:t>
            </a:r>
            <a:endParaRPr lang="en-US" altLang="ko-KR" sz="1200" dirty="0"/>
          </a:p>
          <a:p>
            <a:r>
              <a:rPr lang="en-US" altLang="ko-KR" sz="1200" dirty="0"/>
              <a:t>- HE = High Fat Diet + Exercise</a:t>
            </a:r>
          </a:p>
          <a:p>
            <a:r>
              <a:rPr lang="en-US" altLang="ko-KR" sz="1200" dirty="0"/>
              <a:t>- HGE =High Fat Diet + </a:t>
            </a:r>
            <a:r>
              <a:rPr lang="en-US" altLang="ko-KR" sz="1200" dirty="0" err="1"/>
              <a:t>Genistein</a:t>
            </a:r>
            <a:r>
              <a:rPr lang="en-US" altLang="ko-KR" sz="1200" dirty="0"/>
              <a:t> + Exercise</a:t>
            </a:r>
            <a:endParaRPr lang="ko-KR" altLang="en-US" sz="1200" dirty="0"/>
          </a:p>
        </p:txBody>
      </p:sp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837890" y="1576807"/>
            <a:ext cx="14199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GAPDH</a:t>
            </a:r>
          </a:p>
          <a:p>
            <a:pPr algn="ctr"/>
            <a:r>
              <a:rPr lang="en-US" altLang="ko-KR" sz="1400" b="1" dirty="0"/>
              <a:t>(27cycle)</a:t>
            </a:r>
          </a:p>
          <a:p>
            <a:pPr algn="ctr"/>
            <a:endParaRPr lang="en-US" altLang="ko-KR" sz="1200" b="1" dirty="0"/>
          </a:p>
        </p:txBody>
      </p:sp>
      <p:sp>
        <p:nvSpPr>
          <p:cNvPr id="33" name="TextBox 7">
            <a:extLst>
              <a:ext uri="{FF2B5EF4-FFF2-40B4-BE49-F238E27FC236}">
                <a16:creationId xmlns:a16="http://schemas.microsoft.com/office/drawing/2014/main" id="{7C39B5F1-D550-40B7-A95E-E62D924048FB}"/>
              </a:ext>
            </a:extLst>
          </p:cNvPr>
          <p:cNvSpPr txBox="1"/>
          <p:nvPr/>
        </p:nvSpPr>
        <p:spPr>
          <a:xfrm>
            <a:off x="2786637" y="706625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NC</a:t>
            </a:r>
            <a:endParaRPr lang="ko-KR" altLang="en-US" sz="1400" dirty="0"/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464327" y="702795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23415700-4A8E-5C85-5A94-E7684B807B4F}"/>
              </a:ext>
            </a:extLst>
          </p:cNvPr>
          <p:cNvCxnSpPr>
            <a:cxnSpLocks/>
          </p:cNvCxnSpPr>
          <p:nvPr/>
        </p:nvCxnSpPr>
        <p:spPr>
          <a:xfrm>
            <a:off x="2904723" y="105066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9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4160921" y="705212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4834401" y="721273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5515484" y="700206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3602527" y="1046402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>
            <a:off x="4270725" y="103846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4994326" y="1046402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5689054" y="103846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2276638" y="1214604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1</a:t>
            </a:r>
            <a:endParaRPr lang="ko-KR" alt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2A151AD-B625-497B-A363-E403F1937558}"/>
              </a:ext>
            </a:extLst>
          </p:cNvPr>
          <p:cNvSpPr txBox="1"/>
          <p:nvPr/>
        </p:nvSpPr>
        <p:spPr>
          <a:xfrm>
            <a:off x="2253869" y="1746084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70CFF96-9FB4-4512-8A5F-069D06B6E48A}"/>
              </a:ext>
            </a:extLst>
          </p:cNvPr>
          <p:cNvSpPr txBox="1"/>
          <p:nvPr/>
        </p:nvSpPr>
        <p:spPr>
          <a:xfrm>
            <a:off x="2246094" y="231204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3</a:t>
            </a:r>
            <a:endParaRPr lang="ko-KR" alt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4C7153A-7806-4797-B426-23ACC23EEC33}"/>
              </a:ext>
            </a:extLst>
          </p:cNvPr>
          <p:cNvSpPr txBox="1"/>
          <p:nvPr/>
        </p:nvSpPr>
        <p:spPr>
          <a:xfrm>
            <a:off x="2246094" y="293028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4</a:t>
            </a:r>
            <a:endParaRPr lang="ko-KR" alt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97761C3-B14E-48CA-911A-2444FCB04C54}"/>
              </a:ext>
            </a:extLst>
          </p:cNvPr>
          <p:cNvSpPr txBox="1"/>
          <p:nvPr/>
        </p:nvSpPr>
        <p:spPr>
          <a:xfrm>
            <a:off x="2246094" y="360486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5</a:t>
            </a:r>
            <a:endParaRPr lang="ko-KR" altLang="en-US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A49FBA6-B633-4A74-AAAC-325B402B1C5E}"/>
              </a:ext>
            </a:extLst>
          </p:cNvPr>
          <p:cNvSpPr txBox="1"/>
          <p:nvPr/>
        </p:nvSpPr>
        <p:spPr>
          <a:xfrm>
            <a:off x="2253869" y="4224420"/>
            <a:ext cx="450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#6</a:t>
            </a:r>
            <a:endParaRPr lang="ko-KR" alt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2C9F837-8355-433F-B8D2-D42284C80598}"/>
              </a:ext>
            </a:extLst>
          </p:cNvPr>
          <p:cNvSpPr txBox="1"/>
          <p:nvPr/>
        </p:nvSpPr>
        <p:spPr>
          <a:xfrm>
            <a:off x="2246094" y="495022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8</a:t>
            </a:r>
            <a:endParaRPr lang="ko-KR" alt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ADC5EE5-5408-465C-BA50-0E0DA7D7E0EF}"/>
              </a:ext>
            </a:extLst>
          </p:cNvPr>
          <p:cNvSpPr txBox="1"/>
          <p:nvPr/>
        </p:nvSpPr>
        <p:spPr>
          <a:xfrm>
            <a:off x="2252304" y="562860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9</a:t>
            </a:r>
            <a:endParaRPr lang="ko-KR" alt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CA45A47-4ED4-482E-8068-9395F9E027B6}"/>
              </a:ext>
            </a:extLst>
          </p:cNvPr>
          <p:cNvSpPr txBox="1"/>
          <p:nvPr/>
        </p:nvSpPr>
        <p:spPr>
          <a:xfrm>
            <a:off x="2023527" y="6255552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7,10</a:t>
            </a:r>
            <a:endParaRPr lang="ko-KR" altLang="en-US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D86CF8CD-6C5D-45C1-B576-5E9BF2324F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4401" y="1211251"/>
            <a:ext cx="3509571" cy="420462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D59326B8-55FD-4BC1-B428-F6F33C44EB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04401" y="1727239"/>
            <a:ext cx="3509571" cy="380348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6DDD4D10-55BD-4E35-85F3-5A8C9B39E4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03042" y="2310951"/>
            <a:ext cx="3509571" cy="383327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5576BF2C-4D62-4AF8-9E12-8125E3AF145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03042" y="2919604"/>
            <a:ext cx="3509571" cy="434353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C9D93F87-C465-4FA9-B38C-C11C8BD7B50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03042" y="3564671"/>
            <a:ext cx="3516831" cy="367313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13893054-5EE8-4AFE-9828-1711BE0B0E8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89594" y="4181954"/>
            <a:ext cx="3516831" cy="395150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3621A4E2-3315-4940-96BC-32498205DC0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98386" y="4891580"/>
            <a:ext cx="3514227" cy="383559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2DDDF0FC-7C19-4744-A910-12E18C7D0017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798386" y="5556775"/>
            <a:ext cx="3523496" cy="423950"/>
          </a:xfrm>
          <a:prstGeom prst="rect">
            <a:avLst/>
          </a:prstGeom>
        </p:spPr>
      </p:pic>
      <p:pic>
        <p:nvPicPr>
          <p:cNvPr id="28" name="그림 27">
            <a:extLst>
              <a:ext uri="{FF2B5EF4-FFF2-40B4-BE49-F238E27FC236}">
                <a16:creationId xmlns:a16="http://schemas.microsoft.com/office/drawing/2014/main" id="{99B86D1D-EAE4-4CA8-B02E-F9FE106768C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786637" y="6163275"/>
            <a:ext cx="5033060" cy="531441"/>
          </a:xfrm>
          <a:prstGeom prst="rect">
            <a:avLst/>
          </a:prstGeom>
        </p:spPr>
      </p:pic>
      <p:sp>
        <p:nvSpPr>
          <p:cNvPr id="38" name="직사각형 37">
            <a:extLst>
              <a:ext uri="{FF2B5EF4-FFF2-40B4-BE49-F238E27FC236}">
                <a16:creationId xmlns:a16="http://schemas.microsoft.com/office/drawing/2014/main" id="{61038681-7E22-4175-BFF2-0D2C30F782E1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B900486-1C81-465C-BCF5-35F88248A65B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 err="1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Gapdh</a:t>
            </a:r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; loading control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8175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817740" y="5912385"/>
            <a:ext cx="3321710" cy="83099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 H = High Fat Diet</a:t>
            </a:r>
          </a:p>
          <a:p>
            <a:r>
              <a:rPr lang="en-US" altLang="ko-KR" sz="1200" dirty="0"/>
              <a:t>- HG =High Fat Diet + </a:t>
            </a:r>
            <a:r>
              <a:rPr lang="en-US" altLang="ko-KR" sz="1200" dirty="0" err="1"/>
              <a:t>Genistein</a:t>
            </a:r>
            <a:endParaRPr lang="en-US" altLang="ko-KR" sz="1200" dirty="0"/>
          </a:p>
          <a:p>
            <a:r>
              <a:rPr lang="en-US" altLang="ko-KR" sz="1200" dirty="0"/>
              <a:t>- HE = High Fat Diet + Exercise</a:t>
            </a:r>
          </a:p>
          <a:p>
            <a:r>
              <a:rPr lang="en-US" altLang="ko-KR" sz="1200" dirty="0"/>
              <a:t>- HGE =High Fat Diet + </a:t>
            </a:r>
            <a:r>
              <a:rPr lang="en-US" altLang="ko-KR" sz="1200" dirty="0" err="1"/>
              <a:t>Genistein</a:t>
            </a:r>
            <a:r>
              <a:rPr lang="en-US" altLang="ko-KR" sz="1200" dirty="0"/>
              <a:t> + Exercise</a:t>
            </a:r>
            <a:endParaRPr lang="ko-KR" altLang="en-US" sz="1200" dirty="0"/>
          </a:p>
        </p:txBody>
      </p:sp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837890" y="1576807"/>
            <a:ext cx="14199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ATGL</a:t>
            </a:r>
          </a:p>
          <a:p>
            <a:pPr algn="ctr"/>
            <a:r>
              <a:rPr lang="en-US" altLang="ko-KR" sz="1400" b="1" dirty="0"/>
              <a:t>(29cycle)</a:t>
            </a:r>
          </a:p>
          <a:p>
            <a:pPr algn="ctr"/>
            <a:endParaRPr lang="en-US" altLang="ko-KR" sz="1200" b="1" dirty="0"/>
          </a:p>
        </p:txBody>
      </p:sp>
      <p:sp>
        <p:nvSpPr>
          <p:cNvPr id="33" name="TextBox 7">
            <a:extLst>
              <a:ext uri="{FF2B5EF4-FFF2-40B4-BE49-F238E27FC236}">
                <a16:creationId xmlns:a16="http://schemas.microsoft.com/office/drawing/2014/main" id="{7C39B5F1-D550-40B7-A95E-E62D924048FB}"/>
              </a:ext>
            </a:extLst>
          </p:cNvPr>
          <p:cNvSpPr txBox="1"/>
          <p:nvPr/>
        </p:nvSpPr>
        <p:spPr>
          <a:xfrm>
            <a:off x="2786637" y="706625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NC</a:t>
            </a:r>
            <a:endParaRPr lang="ko-KR" altLang="en-US" sz="1400" dirty="0"/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464327" y="702795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23415700-4A8E-5C85-5A94-E7684B807B4F}"/>
              </a:ext>
            </a:extLst>
          </p:cNvPr>
          <p:cNvCxnSpPr>
            <a:cxnSpLocks/>
          </p:cNvCxnSpPr>
          <p:nvPr/>
        </p:nvCxnSpPr>
        <p:spPr>
          <a:xfrm>
            <a:off x="2904723" y="105066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9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4160921" y="705212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4834401" y="721273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5515484" y="700206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3602527" y="1046402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>
            <a:off x="4270725" y="103846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4994326" y="1046402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5689054" y="103846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2276638" y="1214604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1</a:t>
            </a:r>
            <a:endParaRPr lang="ko-KR" alt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2A151AD-B625-497B-A363-E403F1937558}"/>
              </a:ext>
            </a:extLst>
          </p:cNvPr>
          <p:cNvSpPr txBox="1"/>
          <p:nvPr/>
        </p:nvSpPr>
        <p:spPr>
          <a:xfrm>
            <a:off x="2253869" y="1746084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2</a:t>
            </a:r>
          </a:p>
        </p:txBody>
      </p:sp>
      <p:pic>
        <p:nvPicPr>
          <p:cNvPr id="19" name="그림 18">
            <a:extLst>
              <a:ext uri="{FF2B5EF4-FFF2-40B4-BE49-F238E27FC236}">
                <a16:creationId xmlns:a16="http://schemas.microsoft.com/office/drawing/2014/main" id="{9F328D21-6717-45B4-909B-DAD4EC1D23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7006" y="1196335"/>
            <a:ext cx="3514228" cy="423753"/>
          </a:xfrm>
          <a:prstGeom prst="rect">
            <a:avLst/>
          </a:prstGeom>
        </p:spPr>
      </p:pic>
      <p:pic>
        <p:nvPicPr>
          <p:cNvPr id="2" name="그림 1">
            <a:extLst>
              <a:ext uri="{FF2B5EF4-FFF2-40B4-BE49-F238E27FC236}">
                <a16:creationId xmlns:a16="http://schemas.microsoft.com/office/drawing/2014/main" id="{00C38CEB-745B-4456-B6C7-08B44FC80C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07006" y="1725906"/>
            <a:ext cx="3514229" cy="472929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470CFF96-9FB4-4512-8A5F-069D06B6E48A}"/>
              </a:ext>
            </a:extLst>
          </p:cNvPr>
          <p:cNvSpPr txBox="1"/>
          <p:nvPr/>
        </p:nvSpPr>
        <p:spPr>
          <a:xfrm>
            <a:off x="2246094" y="231204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3</a:t>
            </a:r>
            <a:endParaRPr lang="ko-KR" alt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4C7153A-7806-4797-B426-23ACC23EEC33}"/>
              </a:ext>
            </a:extLst>
          </p:cNvPr>
          <p:cNvSpPr txBox="1"/>
          <p:nvPr/>
        </p:nvSpPr>
        <p:spPr>
          <a:xfrm>
            <a:off x="2246094" y="293028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4</a:t>
            </a:r>
            <a:endParaRPr lang="ko-KR" alt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97761C3-B14E-48CA-911A-2444FCB04C54}"/>
              </a:ext>
            </a:extLst>
          </p:cNvPr>
          <p:cNvSpPr txBox="1"/>
          <p:nvPr/>
        </p:nvSpPr>
        <p:spPr>
          <a:xfrm>
            <a:off x="2246094" y="360486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5</a:t>
            </a:r>
            <a:endParaRPr lang="ko-KR" altLang="en-US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79DDED75-507E-4668-9BA7-811E7ED5DF8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04401" y="2292691"/>
            <a:ext cx="3509570" cy="479505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B6FC8162-D598-45EF-88E9-1F404442000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05819" y="2920335"/>
            <a:ext cx="3515413" cy="465275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A7AD06D9-8034-4124-A5D0-6D6EA31699B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05819" y="3555600"/>
            <a:ext cx="3508152" cy="575107"/>
          </a:xfrm>
          <a:prstGeom prst="rect">
            <a:avLst/>
          </a:prstGeom>
        </p:spPr>
      </p:pic>
      <p:sp>
        <p:nvSpPr>
          <p:cNvPr id="38" name="직사각형 37">
            <a:extLst>
              <a:ext uri="{FF2B5EF4-FFF2-40B4-BE49-F238E27FC236}">
                <a16:creationId xmlns:a16="http://schemas.microsoft.com/office/drawing/2014/main" id="{35616DAE-D590-40E9-B2E2-198510418111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90F922D-F460-455B-A29E-34830C91521E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TGL; lipolysis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C12EBFE-6071-494C-B0EB-DC350AD52F62}"/>
              </a:ext>
            </a:extLst>
          </p:cNvPr>
          <p:cNvSpPr txBox="1"/>
          <p:nvPr/>
        </p:nvSpPr>
        <p:spPr>
          <a:xfrm>
            <a:off x="2246094" y="495022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8</a:t>
            </a:r>
            <a:endParaRPr lang="ko-KR" alt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E9A7852-0A75-4379-81EB-31C708385FEA}"/>
              </a:ext>
            </a:extLst>
          </p:cNvPr>
          <p:cNvSpPr txBox="1"/>
          <p:nvPr/>
        </p:nvSpPr>
        <p:spPr>
          <a:xfrm>
            <a:off x="2252304" y="562860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9</a:t>
            </a:r>
            <a:endParaRPr lang="ko-KR" altLang="en-US" dirty="0"/>
          </a:p>
        </p:txBody>
      </p:sp>
      <p:pic>
        <p:nvPicPr>
          <p:cNvPr id="10" name="그림 9">
            <a:extLst>
              <a:ext uri="{FF2B5EF4-FFF2-40B4-BE49-F238E27FC236}">
                <a16:creationId xmlns:a16="http://schemas.microsoft.com/office/drawing/2014/main" id="{373C3F0D-4DEF-47EE-8CF4-9CE11F831E6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04400" y="4879597"/>
            <a:ext cx="3515413" cy="504352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07263C78-795E-4BB7-B9C2-3E817CC2542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804400" y="5566845"/>
            <a:ext cx="3516832" cy="474616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7B130DAD-4FC4-46D2-9CA4-1DDE30B758F7}"/>
              </a:ext>
            </a:extLst>
          </p:cNvPr>
          <p:cNvSpPr txBox="1"/>
          <p:nvPr/>
        </p:nvSpPr>
        <p:spPr>
          <a:xfrm>
            <a:off x="2253869" y="4279441"/>
            <a:ext cx="450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#6</a:t>
            </a:r>
            <a:endParaRPr lang="ko-KR" alt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4C3EBBF-651A-4277-A52B-8D87EEAE46C4}"/>
              </a:ext>
            </a:extLst>
          </p:cNvPr>
          <p:cNvSpPr txBox="1"/>
          <p:nvPr/>
        </p:nvSpPr>
        <p:spPr>
          <a:xfrm>
            <a:off x="2023527" y="6255552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7,10</a:t>
            </a:r>
            <a:endParaRPr lang="ko-KR" altLang="en-US" dirty="0"/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C8D3FE43-F531-425D-9426-C1540073355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804399" y="4223723"/>
            <a:ext cx="3515412" cy="553798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E90A2BA4-85DC-4725-818D-A92DF2677AC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04399" y="6157794"/>
            <a:ext cx="5010150" cy="523875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C9069DAF-EB3D-409A-9D26-38418DFD405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814549" y="2255437"/>
            <a:ext cx="3971925" cy="2600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04764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817740" y="5912385"/>
            <a:ext cx="3321710" cy="83099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 H = High Fat Diet</a:t>
            </a:r>
          </a:p>
          <a:p>
            <a:r>
              <a:rPr lang="en-US" altLang="ko-KR" sz="1200" dirty="0"/>
              <a:t>- HG =High Fat Diet + </a:t>
            </a:r>
            <a:r>
              <a:rPr lang="en-US" altLang="ko-KR" sz="1200" dirty="0" err="1"/>
              <a:t>Genistein</a:t>
            </a:r>
            <a:endParaRPr lang="en-US" altLang="ko-KR" sz="1200" dirty="0"/>
          </a:p>
          <a:p>
            <a:r>
              <a:rPr lang="en-US" altLang="ko-KR" sz="1200" dirty="0"/>
              <a:t>- HE = High Fat Diet + Exercise</a:t>
            </a:r>
          </a:p>
          <a:p>
            <a:r>
              <a:rPr lang="en-US" altLang="ko-KR" sz="1200" dirty="0"/>
              <a:t>- HGE =High Fat Diet + </a:t>
            </a:r>
            <a:r>
              <a:rPr lang="en-US" altLang="ko-KR" sz="1200" dirty="0" err="1"/>
              <a:t>Genistein</a:t>
            </a:r>
            <a:r>
              <a:rPr lang="en-US" altLang="ko-KR" sz="1200" dirty="0"/>
              <a:t> + Exercise</a:t>
            </a:r>
            <a:endParaRPr lang="ko-KR" altLang="en-US" sz="1200" dirty="0"/>
          </a:p>
        </p:txBody>
      </p:sp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869435" y="1513929"/>
            <a:ext cx="14199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HSL</a:t>
            </a:r>
          </a:p>
          <a:p>
            <a:pPr algn="ctr"/>
            <a:r>
              <a:rPr lang="en-US" altLang="ko-KR" sz="1400" b="1" dirty="0"/>
              <a:t>(29cycle)</a:t>
            </a:r>
          </a:p>
          <a:p>
            <a:pPr algn="ctr"/>
            <a:endParaRPr lang="en-US" altLang="ko-KR" sz="1200" b="1" dirty="0"/>
          </a:p>
        </p:txBody>
      </p:sp>
      <p:sp>
        <p:nvSpPr>
          <p:cNvPr id="33" name="TextBox 7">
            <a:extLst>
              <a:ext uri="{FF2B5EF4-FFF2-40B4-BE49-F238E27FC236}">
                <a16:creationId xmlns:a16="http://schemas.microsoft.com/office/drawing/2014/main" id="{7C39B5F1-D550-40B7-A95E-E62D924048FB}"/>
              </a:ext>
            </a:extLst>
          </p:cNvPr>
          <p:cNvSpPr txBox="1"/>
          <p:nvPr/>
        </p:nvSpPr>
        <p:spPr>
          <a:xfrm>
            <a:off x="2799400" y="665893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NC</a:t>
            </a:r>
            <a:endParaRPr lang="ko-KR" altLang="en-US" sz="1400" dirty="0"/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477090" y="662063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23415700-4A8E-5C85-5A94-E7684B807B4F}"/>
              </a:ext>
            </a:extLst>
          </p:cNvPr>
          <p:cNvCxnSpPr>
            <a:cxnSpLocks/>
          </p:cNvCxnSpPr>
          <p:nvPr/>
        </p:nvCxnSpPr>
        <p:spPr>
          <a:xfrm>
            <a:off x="2917486" y="1009934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9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4173684" y="664480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4847164" y="680541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5528247" y="659474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3615290" y="1005670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>
            <a:off x="4283488" y="997737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5007089" y="1005670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5701817" y="997737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2289401" y="1173872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1</a:t>
            </a:r>
            <a:endParaRPr lang="ko-KR" alt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2A151AD-B625-497B-A363-E403F1937558}"/>
              </a:ext>
            </a:extLst>
          </p:cNvPr>
          <p:cNvSpPr txBox="1"/>
          <p:nvPr/>
        </p:nvSpPr>
        <p:spPr>
          <a:xfrm>
            <a:off x="2266632" y="1705352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2</a:t>
            </a: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2F143A01-0E73-45FE-8D13-5D6A4639BA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20417" y="1115650"/>
            <a:ext cx="3514227" cy="398279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B4EF202A-ABD8-47EC-B862-9FAF75138B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20418" y="1667572"/>
            <a:ext cx="3514226" cy="441995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1219FCEC-2692-46B0-825C-69BB6D1D70D6}"/>
              </a:ext>
            </a:extLst>
          </p:cNvPr>
          <p:cNvSpPr txBox="1"/>
          <p:nvPr/>
        </p:nvSpPr>
        <p:spPr>
          <a:xfrm>
            <a:off x="2246094" y="225949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3</a:t>
            </a:r>
            <a:endParaRPr lang="ko-KR" altLang="en-US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9A44783-633D-40AC-8C51-FC7F9F42FE88}"/>
              </a:ext>
            </a:extLst>
          </p:cNvPr>
          <p:cNvSpPr txBox="1"/>
          <p:nvPr/>
        </p:nvSpPr>
        <p:spPr>
          <a:xfrm>
            <a:off x="2246094" y="293028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4</a:t>
            </a:r>
            <a:endParaRPr lang="ko-KR" altLang="en-US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C780A02-9E0B-45B7-A86C-4E4112F69AEF}"/>
              </a:ext>
            </a:extLst>
          </p:cNvPr>
          <p:cNvSpPr txBox="1"/>
          <p:nvPr/>
        </p:nvSpPr>
        <p:spPr>
          <a:xfrm>
            <a:off x="2246094" y="360486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5</a:t>
            </a:r>
            <a:endParaRPr lang="ko-KR" altLang="en-US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92C2799E-96DB-4EC5-BA5B-92F1F9F8F16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12320" y="2220860"/>
            <a:ext cx="3514226" cy="476121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1FE294D8-2E6C-450B-95D4-CF2845790FC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20416" y="2853808"/>
            <a:ext cx="3506130" cy="459820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655042D5-362A-46C4-9790-633B37A18CB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20222" y="3543368"/>
            <a:ext cx="3506130" cy="450949"/>
          </a:xfrm>
          <a:prstGeom prst="rect">
            <a:avLst/>
          </a:prstGeom>
        </p:spPr>
      </p:pic>
      <p:sp>
        <p:nvSpPr>
          <p:cNvPr id="48" name="직사각형 47">
            <a:extLst>
              <a:ext uri="{FF2B5EF4-FFF2-40B4-BE49-F238E27FC236}">
                <a16:creationId xmlns:a16="http://schemas.microsoft.com/office/drawing/2014/main" id="{BC7C57D7-47DD-45CD-9CCB-32D3D5A3E354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E3250BE-D09A-415C-B3B0-33BE9A70C3DD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HSL; lipolysis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6A7ABCF-AD3D-4308-AECE-445A1BDC39B7}"/>
              </a:ext>
            </a:extLst>
          </p:cNvPr>
          <p:cNvSpPr txBox="1"/>
          <p:nvPr/>
        </p:nvSpPr>
        <p:spPr>
          <a:xfrm>
            <a:off x="2246094" y="495022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8</a:t>
            </a:r>
            <a:endParaRPr lang="ko-KR" alt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EAF8B8F-22B2-4DF8-9D4D-A4D7E8767CAC}"/>
              </a:ext>
            </a:extLst>
          </p:cNvPr>
          <p:cNvSpPr txBox="1"/>
          <p:nvPr/>
        </p:nvSpPr>
        <p:spPr>
          <a:xfrm>
            <a:off x="2252304" y="562860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9</a:t>
            </a:r>
            <a:endParaRPr lang="ko-KR" altLang="en-US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23EFDDA-E840-4612-8328-D4C45500C0DB}"/>
              </a:ext>
            </a:extLst>
          </p:cNvPr>
          <p:cNvSpPr txBox="1"/>
          <p:nvPr/>
        </p:nvSpPr>
        <p:spPr>
          <a:xfrm>
            <a:off x="2253869" y="4224420"/>
            <a:ext cx="450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#6</a:t>
            </a:r>
            <a:endParaRPr lang="ko-KR" alt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77F7B49-92FD-4867-903A-CA47DA3AC151}"/>
              </a:ext>
            </a:extLst>
          </p:cNvPr>
          <p:cNvSpPr txBox="1"/>
          <p:nvPr/>
        </p:nvSpPr>
        <p:spPr>
          <a:xfrm>
            <a:off x="2023527" y="6255552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7,10</a:t>
            </a:r>
            <a:endParaRPr lang="ko-KR" altLang="en-US" dirty="0"/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A1E237BD-36DE-4C7F-8CC7-8588D716B0B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99400" y="4910569"/>
            <a:ext cx="3506130" cy="511483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061E496B-105E-49FB-A5D9-91B94570ACF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86690" y="5573985"/>
            <a:ext cx="3506130" cy="535419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34042F53-8289-4730-80D4-5F4BB03287A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95192" y="4154405"/>
            <a:ext cx="3539451" cy="543742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E761BAC2-04EF-4D1C-83C8-A6521D7B2A6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86690" y="6210066"/>
            <a:ext cx="5031430" cy="599983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484538" y="2084066"/>
            <a:ext cx="4157565" cy="27108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86631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49</TotalTime>
  <Words>195</Words>
  <Application>Microsoft Office PowerPoint</Application>
  <PresentationFormat>와이드스크린</PresentationFormat>
  <Paragraphs>66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Calibri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권혜지(식품영양학과)</dc:creator>
  <cp:lastModifiedBy>혜지 권</cp:lastModifiedBy>
  <cp:revision>218</cp:revision>
  <dcterms:created xsi:type="dcterms:W3CDTF">2023-05-24T10:50:48Z</dcterms:created>
  <dcterms:modified xsi:type="dcterms:W3CDTF">2024-05-03T19:04:58Z</dcterms:modified>
</cp:coreProperties>
</file>